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346" autoAdjust="0"/>
  </p:normalViewPr>
  <p:slideViewPr>
    <p:cSldViewPr>
      <p:cViewPr>
        <p:scale>
          <a:sx n="100" d="100"/>
          <a:sy n="100" d="100"/>
        </p:scale>
        <p:origin x="-462" y="-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B23A02-84ED-4D04-B7DB-0F40603EA1E5}" type="datetimeFigureOut">
              <a:rPr kumimoji="1" lang="ja-JP" altLang="en-US" smtClean="0"/>
              <a:t>2017/8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442DD3-9253-40E7-9A93-2CDC0A7156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1935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smtClean="0"/>
              <a:t>Figure S1 *** 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3442DD3-9253-40E7-9A93-2CDC0A71564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60187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3215A-54A2-41D7-933C-ED7C6DFAD8A5}" type="datetimeFigureOut">
              <a:rPr kumimoji="1" lang="ja-JP" altLang="en-US" smtClean="0"/>
              <a:t>2017/8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3132-1972-479B-8FDB-4E0F1D4A9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5874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3215A-54A2-41D7-933C-ED7C6DFAD8A5}" type="datetimeFigureOut">
              <a:rPr kumimoji="1" lang="ja-JP" altLang="en-US" smtClean="0"/>
              <a:t>2017/8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3132-1972-479B-8FDB-4E0F1D4A9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40180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3215A-54A2-41D7-933C-ED7C6DFAD8A5}" type="datetimeFigureOut">
              <a:rPr kumimoji="1" lang="ja-JP" altLang="en-US" smtClean="0"/>
              <a:t>2017/8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3132-1972-479B-8FDB-4E0F1D4A9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5516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3215A-54A2-41D7-933C-ED7C6DFAD8A5}" type="datetimeFigureOut">
              <a:rPr kumimoji="1" lang="ja-JP" altLang="en-US" smtClean="0"/>
              <a:t>2017/8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3132-1972-479B-8FDB-4E0F1D4A9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01711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3215A-54A2-41D7-933C-ED7C6DFAD8A5}" type="datetimeFigureOut">
              <a:rPr kumimoji="1" lang="ja-JP" altLang="en-US" smtClean="0"/>
              <a:t>2017/8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3132-1972-479B-8FDB-4E0F1D4A9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7567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3215A-54A2-41D7-933C-ED7C6DFAD8A5}" type="datetimeFigureOut">
              <a:rPr kumimoji="1" lang="ja-JP" altLang="en-US" smtClean="0"/>
              <a:t>2017/8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3132-1972-479B-8FDB-4E0F1D4A9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7066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3215A-54A2-41D7-933C-ED7C6DFAD8A5}" type="datetimeFigureOut">
              <a:rPr kumimoji="1" lang="ja-JP" altLang="en-US" smtClean="0"/>
              <a:t>2017/8/1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3132-1972-479B-8FDB-4E0F1D4A9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9416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3215A-54A2-41D7-933C-ED7C6DFAD8A5}" type="datetimeFigureOut">
              <a:rPr kumimoji="1" lang="ja-JP" altLang="en-US" smtClean="0"/>
              <a:t>2017/8/1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3132-1972-479B-8FDB-4E0F1D4A9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18416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3215A-54A2-41D7-933C-ED7C6DFAD8A5}" type="datetimeFigureOut">
              <a:rPr kumimoji="1" lang="ja-JP" altLang="en-US" smtClean="0"/>
              <a:t>2017/8/1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3132-1972-479B-8FDB-4E0F1D4A9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6632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3215A-54A2-41D7-933C-ED7C6DFAD8A5}" type="datetimeFigureOut">
              <a:rPr kumimoji="1" lang="ja-JP" altLang="en-US" smtClean="0"/>
              <a:t>2017/8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3132-1972-479B-8FDB-4E0F1D4A9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1393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3215A-54A2-41D7-933C-ED7C6DFAD8A5}" type="datetimeFigureOut">
              <a:rPr kumimoji="1" lang="ja-JP" altLang="en-US" smtClean="0"/>
              <a:t>2017/8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13132-1972-479B-8FDB-4E0F1D4A9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2330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63215A-54A2-41D7-933C-ED7C6DFAD8A5}" type="datetimeFigureOut">
              <a:rPr kumimoji="1" lang="ja-JP" altLang="en-US" smtClean="0"/>
              <a:t>2017/8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713132-1972-479B-8FDB-4E0F1D4A9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8797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032" y="1628800"/>
            <a:ext cx="4243968" cy="25443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34336" y="1673261"/>
            <a:ext cx="4202160" cy="25192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正方形/長方形 5"/>
          <p:cNvSpPr/>
          <p:nvPr/>
        </p:nvSpPr>
        <p:spPr>
          <a:xfrm rot="16200000">
            <a:off x="-677359" y="2575542"/>
            <a:ext cx="17027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ating score of arousal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 rot="16200000">
            <a:off x="3790862" y="2611116"/>
            <a:ext cx="17283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ating score of valence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173996" y="442705"/>
            <a:ext cx="8515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S1 Fig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26"/>
          <p:cNvSpPr>
            <a:spLocks noChangeArrowheads="1"/>
          </p:cNvSpPr>
          <p:nvPr/>
        </p:nvSpPr>
        <p:spPr bwMode="auto">
          <a:xfrm>
            <a:off x="1091201" y="3933056"/>
            <a:ext cx="960519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low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empo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27"/>
          <p:cNvSpPr>
            <a:spLocks noChangeArrowheads="1"/>
          </p:cNvSpPr>
          <p:nvPr/>
        </p:nvSpPr>
        <p:spPr bwMode="auto">
          <a:xfrm>
            <a:off x="3053049" y="3933056"/>
            <a:ext cx="902811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ast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empo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26"/>
          <p:cNvSpPr>
            <a:spLocks noChangeArrowheads="1"/>
          </p:cNvSpPr>
          <p:nvPr/>
        </p:nvSpPr>
        <p:spPr bwMode="auto">
          <a:xfrm>
            <a:off x="5652120" y="3933056"/>
            <a:ext cx="960519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low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empo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27"/>
          <p:cNvSpPr>
            <a:spLocks noChangeArrowheads="1"/>
          </p:cNvSpPr>
          <p:nvPr/>
        </p:nvSpPr>
        <p:spPr bwMode="auto">
          <a:xfrm>
            <a:off x="7524328" y="3942581"/>
            <a:ext cx="902811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ast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empo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線コネクタ 15"/>
          <p:cNvCxnSpPr/>
          <p:nvPr/>
        </p:nvCxnSpPr>
        <p:spPr>
          <a:xfrm flipV="1">
            <a:off x="1547664" y="1556792"/>
            <a:ext cx="0" cy="3058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>
            <a:off x="1547664" y="1556792"/>
            <a:ext cx="19768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/>
          <p:cNvCxnSpPr/>
          <p:nvPr/>
        </p:nvCxnSpPr>
        <p:spPr>
          <a:xfrm>
            <a:off x="3524492" y="1556792"/>
            <a:ext cx="0" cy="3058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正方形/長方形 21"/>
          <p:cNvSpPr/>
          <p:nvPr/>
        </p:nvSpPr>
        <p:spPr>
          <a:xfrm>
            <a:off x="2270620" y="1187460"/>
            <a:ext cx="453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線コネクタ 22"/>
          <p:cNvCxnSpPr/>
          <p:nvPr/>
        </p:nvCxnSpPr>
        <p:spPr>
          <a:xfrm flipV="1">
            <a:off x="6123564" y="1494076"/>
            <a:ext cx="0" cy="3058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/>
          <p:cNvCxnSpPr/>
          <p:nvPr/>
        </p:nvCxnSpPr>
        <p:spPr>
          <a:xfrm>
            <a:off x="6123564" y="1494076"/>
            <a:ext cx="18328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/>
          <p:cNvCxnSpPr/>
          <p:nvPr/>
        </p:nvCxnSpPr>
        <p:spPr>
          <a:xfrm>
            <a:off x="7965901" y="1494076"/>
            <a:ext cx="0" cy="3058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正方形/長方形 25"/>
          <p:cNvSpPr/>
          <p:nvPr/>
        </p:nvSpPr>
        <p:spPr>
          <a:xfrm>
            <a:off x="6961862" y="1124744"/>
            <a:ext cx="3642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正方形/長方形 26"/>
          <p:cNvSpPr/>
          <p:nvPr/>
        </p:nvSpPr>
        <p:spPr>
          <a:xfrm>
            <a:off x="128990" y="1043444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正方形/長方形 27"/>
          <p:cNvSpPr/>
          <p:nvPr/>
        </p:nvSpPr>
        <p:spPr>
          <a:xfrm>
            <a:off x="4860032" y="1115452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6113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7</TotalTime>
  <Words>26</Words>
  <Application>Microsoft Office PowerPoint</Application>
  <PresentationFormat>画面に合わせる (4:3)</PresentationFormat>
  <Paragraphs>13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uki ooishi</dc:creator>
  <cp:lastModifiedBy>yuuki ooishi</cp:lastModifiedBy>
  <cp:revision>22</cp:revision>
  <dcterms:created xsi:type="dcterms:W3CDTF">2016-11-27T08:35:00Z</dcterms:created>
  <dcterms:modified xsi:type="dcterms:W3CDTF">2017-08-10T02:37:39Z</dcterms:modified>
</cp:coreProperties>
</file>